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4" d="100"/>
          <a:sy n="94" d="100"/>
        </p:scale>
        <p:origin x="3106" y="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3410D-B221-4143-9249-BC7D3192F08A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7609E-609B-7149-978A-ECC54F4B6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9944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3410D-B221-4143-9249-BC7D3192F08A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7609E-609B-7149-978A-ECC54F4B6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653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3410D-B221-4143-9249-BC7D3192F08A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7609E-609B-7149-978A-ECC54F4B6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937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3410D-B221-4143-9249-BC7D3192F08A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7609E-609B-7149-978A-ECC54F4B6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997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3410D-B221-4143-9249-BC7D3192F08A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7609E-609B-7149-978A-ECC54F4B6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147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3410D-B221-4143-9249-BC7D3192F08A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7609E-609B-7149-978A-ECC54F4B6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496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3410D-B221-4143-9249-BC7D3192F08A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7609E-609B-7149-978A-ECC54F4B6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073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3410D-B221-4143-9249-BC7D3192F08A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7609E-609B-7149-978A-ECC54F4B6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5643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3410D-B221-4143-9249-BC7D3192F08A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7609E-609B-7149-978A-ECC54F4B6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647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3410D-B221-4143-9249-BC7D3192F08A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7609E-609B-7149-978A-ECC54F4B6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160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3410D-B221-4143-9249-BC7D3192F08A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7609E-609B-7149-978A-ECC54F4B6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562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F3410D-B221-4143-9249-BC7D3192F08A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57609E-609B-7149-978A-ECC54F4B6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457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electedFeatures_XX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9" r="11594" b="5767"/>
          <a:stretch/>
        </p:blipFill>
        <p:spPr>
          <a:xfrm>
            <a:off x="1159062" y="0"/>
            <a:ext cx="2278337" cy="2520000"/>
          </a:xfrm>
          <a:prstGeom prst="rect">
            <a:avLst/>
          </a:prstGeom>
        </p:spPr>
      </p:pic>
      <p:pic>
        <p:nvPicPr>
          <p:cNvPr id="5" name="Picture 4" descr="selectedFeatures_XXX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2" r="11853" b="5767"/>
          <a:stretch/>
        </p:blipFill>
        <p:spPr>
          <a:xfrm>
            <a:off x="4072717" y="0"/>
            <a:ext cx="2270533" cy="2520000"/>
          </a:xfrm>
          <a:prstGeom prst="rect">
            <a:avLst/>
          </a:prstGeom>
        </p:spPr>
      </p:pic>
      <p:pic>
        <p:nvPicPr>
          <p:cNvPr id="6" name="Picture 5" descr="selectedFeatures_XXXX_c.pd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1" r="10686" b="5622"/>
          <a:stretch/>
        </p:blipFill>
        <p:spPr>
          <a:xfrm>
            <a:off x="1159062" y="2931761"/>
            <a:ext cx="2305991" cy="2520000"/>
          </a:xfrm>
          <a:prstGeom prst="rect">
            <a:avLst/>
          </a:prstGeom>
        </p:spPr>
      </p:pic>
      <p:pic>
        <p:nvPicPr>
          <p:cNvPr id="7" name="Picture 6" descr="selectedFeatures_XXXX_a.pdf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1" r="11561" b="5654"/>
          <a:stretch/>
        </p:blipFill>
        <p:spPr>
          <a:xfrm>
            <a:off x="4072717" y="2931761"/>
            <a:ext cx="2283383" cy="2520000"/>
          </a:xfrm>
          <a:prstGeom prst="rect">
            <a:avLst/>
          </a:prstGeom>
        </p:spPr>
      </p:pic>
      <p:pic>
        <p:nvPicPr>
          <p:cNvPr id="8" name="Picture 7" descr="selectedFeatures_XXXX_b.pdf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1" r="10978" b="5514"/>
          <a:stretch/>
        </p:blipFill>
        <p:spPr>
          <a:xfrm>
            <a:off x="1141810" y="5887585"/>
            <a:ext cx="2295589" cy="25200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239705" y="8440512"/>
            <a:ext cx="18421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kern="1200" dirty="0" smtClean="0">
                <a:latin typeface="Arial"/>
                <a:cs typeface="Arial"/>
              </a:rPr>
              <a:t>All facets </a:t>
            </a:r>
            <a:r>
              <a:rPr lang="en-US" altLang="zh-CN" sz="1000" b="1" dirty="0">
                <a:latin typeface="Arial"/>
                <a:cs typeface="Arial"/>
              </a:rPr>
              <a:t>cell types/tissues</a:t>
            </a:r>
            <a:endParaRPr lang="en-US" sz="1000" b="1" kern="1200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150475" y="5641364"/>
            <a:ext cx="18421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kern="1200" dirty="0" smtClean="0">
                <a:latin typeface="Arial"/>
                <a:cs typeface="Arial"/>
              </a:rPr>
              <a:t>All facets </a:t>
            </a:r>
            <a:r>
              <a:rPr lang="en-US" altLang="zh-CN" sz="1000" b="1" dirty="0">
                <a:latin typeface="Arial"/>
                <a:cs typeface="Arial"/>
              </a:rPr>
              <a:t>cell types/tissues</a:t>
            </a:r>
            <a:endParaRPr lang="en-US" sz="1000" b="1" kern="1200" dirty="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158519" y="2520000"/>
            <a:ext cx="18421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kern="1200" dirty="0" smtClean="0">
                <a:latin typeface="Arial"/>
                <a:cs typeface="Arial"/>
              </a:rPr>
              <a:t>All facets </a:t>
            </a:r>
            <a:r>
              <a:rPr lang="en-US" altLang="zh-CN" sz="1000" b="1" dirty="0">
                <a:latin typeface="Arial"/>
                <a:cs typeface="Arial"/>
              </a:rPr>
              <a:t>cell types/tissues</a:t>
            </a:r>
            <a:endParaRPr lang="en-US" sz="1000" b="1" kern="1200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239705" y="5518253"/>
            <a:ext cx="18421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kern="1200" dirty="0" smtClean="0">
                <a:latin typeface="Arial"/>
                <a:cs typeface="Arial"/>
              </a:rPr>
              <a:t>All facets </a:t>
            </a:r>
            <a:r>
              <a:rPr lang="en-US" altLang="zh-CN" sz="1000" b="1" dirty="0">
                <a:latin typeface="Arial"/>
                <a:cs typeface="Arial"/>
              </a:rPr>
              <a:t>cell types/tissues</a:t>
            </a:r>
            <a:endParaRPr lang="en-US" sz="1000" b="1" kern="12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239705" y="2535229"/>
            <a:ext cx="18421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kern="1200" dirty="0" smtClean="0">
                <a:latin typeface="Arial"/>
                <a:cs typeface="Arial"/>
              </a:rPr>
              <a:t>All facets </a:t>
            </a:r>
            <a:r>
              <a:rPr lang="en-US" sz="1000" b="1" kern="1200" dirty="0" smtClean="0">
                <a:latin typeface="Arial"/>
                <a:cs typeface="Arial"/>
              </a:rPr>
              <a:t>cell types/tissues</a:t>
            </a:r>
            <a:endParaRPr lang="en-US" sz="1000" b="1" kern="12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392334" y="1145178"/>
            <a:ext cx="1068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Di-nucleotides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3332399" y="1123793"/>
            <a:ext cx="10967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Tri-nucleotides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304421" y="3999068"/>
            <a:ext cx="12440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Tetra-nucleotides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3288051" y="3999067"/>
            <a:ext cx="12440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Tetra-nucleotides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304422" y="7058693"/>
            <a:ext cx="12440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Tetra-nucleotides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-3548347" y="-2686867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-3395947" y="-2534467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-3243547" y="-2382067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53280" y="113600"/>
            <a:ext cx="307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kern="1200" dirty="0">
                <a:latin typeface="Arial"/>
                <a:cs typeface="Arial"/>
              </a:rPr>
              <a:t>A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699470" y="113600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B</a:t>
            </a:r>
            <a:endParaRPr lang="en-US" sz="1400" b="1" kern="1200" dirty="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55639" y="2931761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C</a:t>
            </a:r>
            <a:endParaRPr lang="en-US" sz="1400" b="1" kern="1200" dirty="0">
              <a:latin typeface="Arial"/>
              <a:cs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733092" y="2931761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D</a:t>
            </a:r>
            <a:endParaRPr lang="en-US" sz="1400" b="1" kern="1200" dirty="0"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53280" y="5887585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E</a:t>
            </a:r>
            <a:endParaRPr lang="en-US" sz="1400" b="1" kern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9803362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33</Words>
  <Application>Microsoft Office PowerPoint</Application>
  <PresentationFormat>全屏显示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Theme</vt:lpstr>
      <vt:lpstr>PowerPoint 演示文稿</vt:lpstr>
    </vt:vector>
  </TitlesOfParts>
  <Company>IC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mitrios Kleftogiannis</dc:creator>
  <cp:lastModifiedBy>焦玉霞</cp:lastModifiedBy>
  <cp:revision>6</cp:revision>
  <dcterms:created xsi:type="dcterms:W3CDTF">2018-11-15T13:52:56Z</dcterms:created>
  <dcterms:modified xsi:type="dcterms:W3CDTF">2018-12-09T07:25:40Z</dcterms:modified>
</cp:coreProperties>
</file>